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479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6167"/>
    <p:restoredTop sz="96197"/>
  </p:normalViewPr>
  <p:slideViewPr>
    <p:cSldViewPr snapToGrid="0" snapToObjects="1">
      <p:cViewPr varScale="1">
        <p:scale>
          <a:sx n="103" d="100"/>
          <a:sy n="103" d="100"/>
        </p:scale>
        <p:origin x="192" y="5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29ED93-C095-7643-AC4A-F61AAD759AA3}" type="datetimeFigureOut">
              <a:rPr kumimoji="1" lang="ja-JP" altLang="en-US" smtClean="0"/>
              <a:t>2022/7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72755E4-5CBA-2341-A354-D4F8B93A55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29352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sz="1200" dirty="0">
                <a:solidFill>
                  <a:srgbClr val="002060"/>
                </a:solidFill>
                <a:latin typeface="Century" panose="02040604050505020304" pitchFamily="18" charset="0"/>
                <a:cs typeface="Times New Roman" panose="02020603050405020304" pitchFamily="18" charset="0"/>
              </a:rPr>
              <a:t>Change in the Pre and Post NOS levels after treatment </a:t>
            </a:r>
            <a:endParaRPr lang="en-JP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E4F406-692E-408D-92F1-D05A6523BE3F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73838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C261653-F180-73C6-3F2E-1726B3BE783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EE2B1A4F-1899-58A0-8E32-B1D34A3DC3B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7FB22DD-5ED2-5763-03A5-29BE10BDEA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EEDED-6FDE-7E4E-9EA6-8C9EE9C1FC8E}" type="datetimeFigureOut">
              <a:rPr kumimoji="1" lang="ja-JP" altLang="en-US" smtClean="0"/>
              <a:t>2022/7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F1C8226-C9CF-3CAB-7F80-D60D32785F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CAB3E03-4646-6A44-AA72-BFFAE46076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710F8-3E7C-DE4D-8213-F4E3B220D9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35249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44322E2-BB13-0652-59EA-F89A98DD2B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5644E1E-EA13-2AD8-2A85-C58BAFE2B8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948368D-8048-7C7D-3614-8A80B266D1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EEDED-6FDE-7E4E-9EA6-8C9EE9C1FC8E}" type="datetimeFigureOut">
              <a:rPr kumimoji="1" lang="ja-JP" altLang="en-US" smtClean="0"/>
              <a:t>2022/7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553E87C-845F-AD2D-1CCC-1CCEEDE95F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DB21535-D177-405E-D284-BD1C0F1737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710F8-3E7C-DE4D-8213-F4E3B220D9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43754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F2CC1A9-F964-70ED-958B-165DC074FB9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FB94AD2-8370-6581-4910-4971637E36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1B560CE-1B63-AE74-8F53-39DD4C2F5E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EEDED-6FDE-7E4E-9EA6-8C9EE9C1FC8E}" type="datetimeFigureOut">
              <a:rPr kumimoji="1" lang="ja-JP" altLang="en-US" smtClean="0"/>
              <a:t>2022/7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97A4E82-F862-6DA4-5B03-AAE2BD1FB2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2CF56D9-066B-277B-F4E2-2A9E767A76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710F8-3E7C-DE4D-8213-F4E3B220D9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23190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924E738-E508-E71E-DA1A-DC81EA27D0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AAF3544-87A6-8ED7-D918-0519653B9DB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BAC35F8-67C9-C738-FCF1-EA29D64E40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EEDED-6FDE-7E4E-9EA6-8C9EE9C1FC8E}" type="datetimeFigureOut">
              <a:rPr kumimoji="1" lang="ja-JP" altLang="en-US" smtClean="0"/>
              <a:t>2022/7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D23E4C2-B98E-555B-D086-C3275F38B9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582183E-C4FF-14BF-57B9-A20CF752DE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710F8-3E7C-DE4D-8213-F4E3B220D9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58405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117BCA6-265E-9B5D-4991-2B21D2FFCF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B3101DE-4427-5A59-44DF-0B7011FD1D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DA9CA13-855C-29A4-38A1-22B62370AA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EEDED-6FDE-7E4E-9EA6-8C9EE9C1FC8E}" type="datetimeFigureOut">
              <a:rPr kumimoji="1" lang="ja-JP" altLang="en-US" smtClean="0"/>
              <a:t>2022/7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36B1DBD-1A71-4C30-EAF9-9ACB70502E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121DD84-CE30-6909-1C82-0AB9CF9737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710F8-3E7C-DE4D-8213-F4E3B220D9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56062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7075BDC-72FE-9398-966D-28287917DD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A7C32C0-24FE-1980-843D-8986FEAD681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5BED0E6-A356-06CC-1ABB-0A9845E1A3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D749D2B-2ED5-A179-BD1C-F1ADFA9FE2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EEDED-6FDE-7E4E-9EA6-8C9EE9C1FC8E}" type="datetimeFigureOut">
              <a:rPr kumimoji="1" lang="ja-JP" altLang="en-US" smtClean="0"/>
              <a:t>2022/7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AF042B2-E6FF-368D-46E0-69FED57E1E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E69A23B-1ECD-E740-A224-23BF78F9AF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710F8-3E7C-DE4D-8213-F4E3B220D9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68341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931B1A7-9006-B203-FE82-8F2DD98B24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C87D414-0803-C792-8521-40FD00F16B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3C0CED2-E6EC-BE43-F5E9-6E536C6788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74330856-07C5-8C02-9575-91775C78370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5DB4418B-A144-7B85-CFE8-6364C9204E6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3D6EFF5B-1011-FBDA-97F3-BB39C267CA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EEDED-6FDE-7E4E-9EA6-8C9EE9C1FC8E}" type="datetimeFigureOut">
              <a:rPr kumimoji="1" lang="ja-JP" altLang="en-US" smtClean="0"/>
              <a:t>2022/7/1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8C2A280-F209-7628-D81B-42AE8C1FF1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4DA9F8AA-D5CF-1756-FFD1-66BF220333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710F8-3E7C-DE4D-8213-F4E3B220D9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24402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4F130C0-3215-0303-F7EA-E27CF14507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7BCCB0C3-4E10-AF7E-8678-C508F61326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EEDED-6FDE-7E4E-9EA6-8C9EE9C1FC8E}" type="datetimeFigureOut">
              <a:rPr kumimoji="1" lang="ja-JP" altLang="en-US" smtClean="0"/>
              <a:t>2022/7/1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E3A5CF4-F1B6-59BA-67EB-A20CB6AEE2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4C7E1F7-FAD9-20BC-F18B-7A49DF4F5F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710F8-3E7C-DE4D-8213-F4E3B220D9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98498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F0A62263-96C2-CB7F-C17E-E0B832FEBF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EEDED-6FDE-7E4E-9EA6-8C9EE9C1FC8E}" type="datetimeFigureOut">
              <a:rPr kumimoji="1" lang="ja-JP" altLang="en-US" smtClean="0"/>
              <a:t>2022/7/1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319A0C1E-19AC-ECD4-B097-39FB6E8B50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19850D2-B167-7BD6-5743-B4E951CF89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710F8-3E7C-DE4D-8213-F4E3B220D9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60994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5B42F12-E09B-E6E7-C3A5-02A0C7C736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3ABC3D6-B206-61AE-C13E-D137BC681B9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0D073BE-C0CA-2DA8-66DB-E83FE91E6D3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AA9F7EF-38F8-BAF6-23BD-4B836E8656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EEDED-6FDE-7E4E-9EA6-8C9EE9C1FC8E}" type="datetimeFigureOut">
              <a:rPr kumimoji="1" lang="ja-JP" altLang="en-US" smtClean="0"/>
              <a:t>2022/7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E00E6E5-A66F-3DB8-1860-9D0EB947E5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9BB05E3-EF83-88B0-CC3E-338664CB6B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710F8-3E7C-DE4D-8213-F4E3B220D9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46796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C7E0CF3-3A29-1268-A650-56F2606F6E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5718AD5-8C8A-7A27-5BD6-84E676E41AF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FF507F2-734E-8449-A2D0-72115F46139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5CA2B0A-8B5E-B98A-895D-4969248C2C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EEDED-6FDE-7E4E-9EA6-8C9EE9C1FC8E}" type="datetimeFigureOut">
              <a:rPr kumimoji="1" lang="ja-JP" altLang="en-US" smtClean="0"/>
              <a:t>2022/7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C89FD19-8D3B-A46C-7DDF-1A5344668E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DAED169-1C25-DADE-3BE0-ACC0D03DD1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710F8-3E7C-DE4D-8213-F4E3B220D9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19852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DC82CA2-DF86-2A39-776D-6B32F40337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AE5E455-8E6D-3A77-3649-823147C12B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D8BFF80-A3E4-B0FE-A8A8-F21F10D699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5EEDED-6FDE-7E4E-9EA6-8C9EE9C1FC8E}" type="datetimeFigureOut">
              <a:rPr kumimoji="1" lang="ja-JP" altLang="en-US" smtClean="0"/>
              <a:t>2022/7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6D2F7B6-B4BE-E17A-CA17-48713FBAC0D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CCFBD5B-3927-DD09-A13F-83BF5E73D5C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A710F8-3E7C-DE4D-8213-F4E3B220D9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45184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図 26">
            <a:extLst>
              <a:ext uri="{FF2B5EF4-FFF2-40B4-BE49-F238E27FC236}">
                <a16:creationId xmlns:a16="http://schemas.microsoft.com/office/drawing/2014/main" id="{B5C2B55C-D4F7-410B-BB9B-3CBF8CC69FB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50550" y="1700808"/>
            <a:ext cx="3836369" cy="3810032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DCA0731-733A-4B18-8484-C759A2F7810E}"/>
              </a:ext>
            </a:extLst>
          </p:cNvPr>
          <p:cNvSpPr txBox="1"/>
          <p:nvPr/>
        </p:nvSpPr>
        <p:spPr>
          <a:xfrm>
            <a:off x="3503713" y="2345688"/>
            <a:ext cx="1224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  <a:endParaRPr lang="ja-JP" altLang="en-US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FCF0901-2FDB-4E4F-89D2-FB3747260DDF}"/>
              </a:ext>
            </a:extLst>
          </p:cNvPr>
          <p:cNvSpPr txBox="1"/>
          <p:nvPr/>
        </p:nvSpPr>
        <p:spPr>
          <a:xfrm>
            <a:off x="3503713" y="3068651"/>
            <a:ext cx="1224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  <a:endParaRPr lang="ja-JP" altLang="en-US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3047C89-42BC-47E9-BB56-16C19F7A833E}"/>
              </a:ext>
            </a:extLst>
          </p:cNvPr>
          <p:cNvSpPr txBox="1"/>
          <p:nvPr/>
        </p:nvSpPr>
        <p:spPr>
          <a:xfrm>
            <a:off x="3503713" y="3766476"/>
            <a:ext cx="1224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lang="ja-JP" altLang="en-US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9BDD0F9-3ADA-4D87-879D-DF3B52EAE24F}"/>
              </a:ext>
            </a:extLst>
          </p:cNvPr>
          <p:cNvSpPr txBox="1"/>
          <p:nvPr/>
        </p:nvSpPr>
        <p:spPr>
          <a:xfrm>
            <a:off x="3503713" y="4464301"/>
            <a:ext cx="1224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lang="ja-JP" altLang="en-US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BBDC89BC-BBA6-4B0C-BC69-323E8C28DCCF}"/>
              </a:ext>
            </a:extLst>
          </p:cNvPr>
          <p:cNvSpPr txBox="1"/>
          <p:nvPr/>
        </p:nvSpPr>
        <p:spPr>
          <a:xfrm>
            <a:off x="3503713" y="5160684"/>
            <a:ext cx="1224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  <a:endParaRPr lang="ja-JP" altLang="en-US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5311EEB-A0FC-4E84-8DA1-779FBB09C727}"/>
              </a:ext>
            </a:extLst>
          </p:cNvPr>
          <p:cNvSpPr txBox="1"/>
          <p:nvPr/>
        </p:nvSpPr>
        <p:spPr>
          <a:xfrm>
            <a:off x="3503713" y="1622725"/>
            <a:ext cx="1224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lang="ja-JP" altLang="en-US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72E4C9E-313A-44D3-861B-19797A0FAC06}"/>
              </a:ext>
            </a:extLst>
          </p:cNvPr>
          <p:cNvSpPr txBox="1"/>
          <p:nvPr/>
        </p:nvSpPr>
        <p:spPr>
          <a:xfrm rot="16200000">
            <a:off x="2176718" y="3388350"/>
            <a:ext cx="2448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ue positive</a:t>
            </a:r>
            <a:endParaRPr lang="ja-JP" altLang="en-US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00A11BCA-8907-4E91-BE05-9D467DD55ABF}"/>
              </a:ext>
            </a:extLst>
          </p:cNvPr>
          <p:cNvSpPr txBox="1"/>
          <p:nvPr/>
        </p:nvSpPr>
        <p:spPr>
          <a:xfrm>
            <a:off x="4839507" y="5801110"/>
            <a:ext cx="2448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lse positive</a:t>
            </a:r>
            <a:endParaRPr lang="ja-JP" altLang="en-US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28">
            <a:extLst>
              <a:ext uri="{FF2B5EF4-FFF2-40B4-BE49-F238E27FC236}">
                <a16:creationId xmlns:a16="http://schemas.microsoft.com/office/drawing/2014/main" id="{3F5C62C8-FD3A-437B-A8AB-3BB660044EDE}"/>
              </a:ext>
            </a:extLst>
          </p:cNvPr>
          <p:cNvSpPr txBox="1"/>
          <p:nvPr/>
        </p:nvSpPr>
        <p:spPr>
          <a:xfrm>
            <a:off x="7536160" y="5517232"/>
            <a:ext cx="1224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lang="ja-JP" altLang="en-US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0">
            <a:extLst>
              <a:ext uri="{FF2B5EF4-FFF2-40B4-BE49-F238E27FC236}">
                <a16:creationId xmlns:a16="http://schemas.microsoft.com/office/drawing/2014/main" id="{CBE48DDA-E9D4-4BDC-AA87-7B9CA1AB0F36}"/>
              </a:ext>
            </a:extLst>
          </p:cNvPr>
          <p:cNvSpPr txBox="1"/>
          <p:nvPr/>
        </p:nvSpPr>
        <p:spPr>
          <a:xfrm>
            <a:off x="6804797" y="5517232"/>
            <a:ext cx="1224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  <a:endParaRPr lang="ja-JP" altLang="en-US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1">
            <a:extLst>
              <a:ext uri="{FF2B5EF4-FFF2-40B4-BE49-F238E27FC236}">
                <a16:creationId xmlns:a16="http://schemas.microsoft.com/office/drawing/2014/main" id="{1EFC9A5D-3477-44D3-BE93-910A9CEAB4B6}"/>
              </a:ext>
            </a:extLst>
          </p:cNvPr>
          <p:cNvSpPr txBox="1"/>
          <p:nvPr/>
        </p:nvSpPr>
        <p:spPr>
          <a:xfrm>
            <a:off x="6091990" y="5504448"/>
            <a:ext cx="1224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  <a:endParaRPr lang="ja-JP" altLang="en-US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12">
            <a:extLst>
              <a:ext uri="{FF2B5EF4-FFF2-40B4-BE49-F238E27FC236}">
                <a16:creationId xmlns:a16="http://schemas.microsoft.com/office/drawing/2014/main" id="{2C794FFC-04C1-49D8-9444-8BD9A1F505ED}"/>
              </a:ext>
            </a:extLst>
          </p:cNvPr>
          <p:cNvSpPr txBox="1"/>
          <p:nvPr/>
        </p:nvSpPr>
        <p:spPr>
          <a:xfrm>
            <a:off x="5411391" y="5517232"/>
            <a:ext cx="1224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lang="ja-JP" altLang="en-US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14">
            <a:extLst>
              <a:ext uri="{FF2B5EF4-FFF2-40B4-BE49-F238E27FC236}">
                <a16:creationId xmlns:a16="http://schemas.microsoft.com/office/drawing/2014/main" id="{CE1C8930-4DD6-489A-9008-AC232BEE8D21}"/>
              </a:ext>
            </a:extLst>
          </p:cNvPr>
          <p:cNvSpPr txBox="1"/>
          <p:nvPr/>
        </p:nvSpPr>
        <p:spPr>
          <a:xfrm>
            <a:off x="3958012" y="5507227"/>
            <a:ext cx="1224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  <a:endParaRPr lang="ja-JP" altLang="en-US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13">
            <a:extLst>
              <a:ext uri="{FF2B5EF4-FFF2-40B4-BE49-F238E27FC236}">
                <a16:creationId xmlns:a16="http://schemas.microsoft.com/office/drawing/2014/main" id="{2C202E50-69BB-457C-A31C-D3A27705D4D1}"/>
              </a:ext>
            </a:extLst>
          </p:cNvPr>
          <p:cNvSpPr txBox="1"/>
          <p:nvPr/>
        </p:nvSpPr>
        <p:spPr>
          <a:xfrm>
            <a:off x="4664886" y="5517232"/>
            <a:ext cx="1224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lang="ja-JP" altLang="en-US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98B9240B-6023-4291-A60F-1ED936D1A425}"/>
              </a:ext>
            </a:extLst>
          </p:cNvPr>
          <p:cNvSpPr txBox="1"/>
          <p:nvPr/>
        </p:nvSpPr>
        <p:spPr>
          <a:xfrm>
            <a:off x="5664461" y="3284984"/>
            <a:ext cx="2344553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UC               0.709</a:t>
            </a:r>
          </a:p>
          <a:p>
            <a:r>
              <a:rPr lang="en-US" altLang="ja-JP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t-off            0.8</a:t>
            </a:r>
          </a:p>
          <a:p>
            <a:r>
              <a:rPr lang="en-US" altLang="ja-JP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nsitivity       0.773</a:t>
            </a:r>
          </a:p>
          <a:p>
            <a:r>
              <a:rPr lang="en-US" altLang="ja-JP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-specificity    0.423</a:t>
            </a:r>
          </a:p>
          <a:p>
            <a:endParaRPr lang="en-US" altLang="ja-JP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1">
            <a:extLst>
              <a:ext uri="{FF2B5EF4-FFF2-40B4-BE49-F238E27FC236}">
                <a16:creationId xmlns:a16="http://schemas.microsoft.com/office/drawing/2014/main" id="{16F1E0DD-E6EC-4283-90A4-33ECD7EB1DA3}"/>
              </a:ext>
            </a:extLst>
          </p:cNvPr>
          <p:cNvSpPr/>
          <p:nvPr/>
        </p:nvSpPr>
        <p:spPr>
          <a:xfrm>
            <a:off x="5628436" y="4840395"/>
            <a:ext cx="294191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ange rate in NO</a:t>
            </a:r>
            <a:endParaRPr lang="en-US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6AAE9A48-414D-4083-B32A-5186682C544D}"/>
              </a:ext>
            </a:extLst>
          </p:cNvPr>
          <p:cNvCxnSpPr/>
          <p:nvPr/>
        </p:nvCxnSpPr>
        <p:spPr>
          <a:xfrm>
            <a:off x="5448436" y="5013176"/>
            <a:ext cx="180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5F66A3AF-EA9A-3D45-A4FE-7FDDCAC22DF6}"/>
              </a:ext>
            </a:extLst>
          </p:cNvPr>
          <p:cNvSpPr txBox="1"/>
          <p:nvPr/>
        </p:nvSpPr>
        <p:spPr>
          <a:xfrm>
            <a:off x="1991544" y="332656"/>
            <a:ext cx="30341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</a:t>
            </a:r>
            <a:r>
              <a:rPr lang="en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le 3</a:t>
            </a:r>
          </a:p>
        </p:txBody>
      </p:sp>
    </p:spTree>
    <p:extLst>
      <p:ext uri="{BB962C8B-B14F-4D97-AF65-F5344CB8AC3E}">
        <p14:creationId xmlns:p14="http://schemas.microsoft.com/office/powerpoint/2010/main" val="318644301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</Words>
  <Application>Microsoft Macintosh PowerPoint</Application>
  <PresentationFormat>ワイド画面</PresentationFormat>
  <Paragraphs>2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entury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WAMURA Atsushi</dc:creator>
  <cp:lastModifiedBy>KAWAMURA Atsushi</cp:lastModifiedBy>
  <cp:revision>1</cp:revision>
  <dcterms:created xsi:type="dcterms:W3CDTF">2022-04-21T13:01:40Z</dcterms:created>
  <dcterms:modified xsi:type="dcterms:W3CDTF">2022-07-11T15:01:32Z</dcterms:modified>
</cp:coreProperties>
</file>